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1" d="100"/>
          <a:sy n="61" d="100"/>
        </p:scale>
        <p:origin x="77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627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491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577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237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614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456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587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587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789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70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04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5C6490-D96D-4A72-BE85-54C258CD4ACC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CBB386-903A-41A1-B085-F0687B53381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297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1039091" y="1840583"/>
            <a:ext cx="10116589" cy="412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b="1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n vivo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quantification of surfactin </a:t>
            </a:r>
            <a:r>
              <a:rPr lang="en-US" b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onribosomal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eptide synthetase complexes in </a:t>
            </a:r>
            <a:r>
              <a:rPr lang="en-US" b="1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acillus subtilis</a:t>
            </a:r>
            <a:endParaRPr lang="en-US" sz="1400" i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aliheh Vahidinasab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*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Lisa Thewes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Bahar Abrishamchi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Lars Lilge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Susanne Reiße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lvio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Henrique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enatto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erino</a:t>
            </a: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40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udolf Hausmann</a:t>
            </a:r>
            <a:r>
              <a:rPr lang="en-US" sz="1400" baseline="3000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*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epartment of Bioprocess Engineering (150k), Institute of Food Science and Biotechnology, University of Hohenheim, 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ruwirthstrasse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12, 70599 Stuttgart, Germany 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maging Unit, Core Facility of Hohenheim, Emil-Wolff-</a:t>
            </a:r>
            <a:r>
              <a:rPr lang="en-US" sz="14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trasse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12, 70599 Stuttgart, Germany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*Corresponding author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hidin@uni-Hohenheim.de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udolf.Hausmann@uni-Hohenheim.de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2521501" y="546536"/>
            <a:ext cx="6867144" cy="11387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 2</a:t>
            </a:r>
          </a:p>
          <a:p>
            <a:pPr algn="ctr"/>
            <a:endParaRPr lang="de-DE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de-DE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8071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88F80-0CAC-7985-7EE3-305C698B9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2. </a:t>
            </a:r>
            <a:r>
              <a:rPr lang="de-DE" dirty="0" err="1"/>
              <a:t>mEGFP</a:t>
            </a:r>
            <a:r>
              <a:rPr lang="de-DE" dirty="0"/>
              <a:t> </a:t>
            </a:r>
            <a:r>
              <a:rPr lang="de-DE" dirty="0" err="1"/>
              <a:t>calibration</a:t>
            </a:r>
            <a:r>
              <a:rPr lang="de-DE" dirty="0"/>
              <a:t> </a:t>
            </a:r>
            <a:r>
              <a:rPr lang="de-DE" dirty="0" err="1"/>
              <a:t>using</a:t>
            </a:r>
            <a:r>
              <a:rPr lang="de-DE" dirty="0"/>
              <a:t> </a:t>
            </a:r>
            <a:r>
              <a:rPr lang="de-DE" dirty="0" err="1"/>
              <a:t>FPCountR</a:t>
            </a:r>
            <a:r>
              <a:rPr lang="de-DE" dirty="0"/>
              <a:t>*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5D453EA-3B7E-0178-E075-A2D47D657976}"/>
              </a:ext>
            </a:extLst>
          </p:cNvPr>
          <p:cNvSpPr txBox="1"/>
          <p:nvPr/>
        </p:nvSpPr>
        <p:spPr>
          <a:xfrm>
            <a:off x="838200" y="1811773"/>
            <a:ext cx="5613400" cy="4339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molecules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relative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units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llect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measuri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ignal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ollowi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aramete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lter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: ex485/12nm, em520; gain:1000;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lashe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: 21,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bottom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ptic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Fitting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model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relate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molecul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alculat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relative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units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alcula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rrespondi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nvers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acto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generate_cf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()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7B6984-0A4D-8B70-6776-68D763FA3703}"/>
              </a:ext>
            </a:extLst>
          </p:cNvPr>
          <p:cNvSpPr txBox="1"/>
          <p:nvPr/>
        </p:nvSpPr>
        <p:spPr>
          <a:xfrm>
            <a:off x="423434" y="6097696"/>
            <a:ext cx="6302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ibra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., Stan, G.-B., Absolute protein quantification using fluorescence measurements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PCountR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mun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22,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6600. doi:10.1038/s41467-022-34232-6</a:t>
            </a:r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96177534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88F80-0CAC-7985-7EE3-305C698B9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2. </a:t>
            </a:r>
            <a:r>
              <a:rPr lang="de-DE" dirty="0" err="1"/>
              <a:t>mEGFP</a:t>
            </a:r>
            <a:r>
              <a:rPr lang="de-DE" dirty="0"/>
              <a:t> </a:t>
            </a:r>
            <a:r>
              <a:rPr lang="de-DE" dirty="0" err="1"/>
              <a:t>calibration</a:t>
            </a:r>
            <a:r>
              <a:rPr lang="de-DE" dirty="0"/>
              <a:t> </a:t>
            </a:r>
            <a:r>
              <a:rPr lang="de-DE" dirty="0" err="1"/>
              <a:t>using</a:t>
            </a:r>
            <a:r>
              <a:rPr lang="de-DE" dirty="0"/>
              <a:t> </a:t>
            </a:r>
            <a:r>
              <a:rPr lang="de-DE" dirty="0" err="1"/>
              <a:t>FPCountR</a:t>
            </a:r>
            <a:r>
              <a:rPr lang="de-DE" dirty="0"/>
              <a:t>*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5D453EA-3B7E-0178-E075-A2D47D657976}"/>
              </a:ext>
            </a:extLst>
          </p:cNvPr>
          <p:cNvSpPr txBox="1"/>
          <p:nvPr/>
        </p:nvSpPr>
        <p:spPr>
          <a:xfrm>
            <a:off x="838200" y="1690688"/>
            <a:ext cx="7614920" cy="53245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S9.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orrelatio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molecules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relative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luoresce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units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Resulting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cf: </a:t>
            </a:r>
          </a:p>
          <a:p>
            <a:pPr lvl="1"/>
            <a:r>
              <a:rPr lang="en-US" sz="16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f</a:t>
            </a:r>
            <a:r>
              <a:rPr lang="en-US" sz="16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GFP,FLUOstar,filter:ex485/12nm,em520nm,gain1000</a:t>
            </a: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8.75*10</a:t>
            </a:r>
            <a:r>
              <a:rPr lang="en-US" sz="16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10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7B6984-0A4D-8B70-6776-68D763FA3703}"/>
              </a:ext>
            </a:extLst>
          </p:cNvPr>
          <p:cNvSpPr txBox="1"/>
          <p:nvPr/>
        </p:nvSpPr>
        <p:spPr>
          <a:xfrm>
            <a:off x="423434" y="6097696"/>
            <a:ext cx="6302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ibra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., Stan, G.-B., Absolute protein quantification using fluorescence measurements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PCountR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mun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22,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6600. doi:10.1038/s41467-022-34232-6</a:t>
            </a:r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95B80E27-6B8D-A2DC-07AC-C4ACED24AEEF}"/>
              </a:ext>
            </a:extLst>
          </p:cNvPr>
          <p:cNvGrpSpPr/>
          <p:nvPr/>
        </p:nvGrpSpPr>
        <p:grpSpPr>
          <a:xfrm>
            <a:off x="4165600" y="1988343"/>
            <a:ext cx="7540065" cy="3811697"/>
            <a:chOff x="95250" y="1228665"/>
            <a:chExt cx="10614735" cy="5459534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8F31796C-1CAD-16BF-C5F2-3EB13A4537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639"/>
            <a:stretch/>
          </p:blipFill>
          <p:spPr>
            <a:xfrm>
              <a:off x="95250" y="1362015"/>
              <a:ext cx="4925086" cy="5055113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CBFCE2A2-269F-CB3D-2B43-8CE88786C72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87265" y="1228665"/>
              <a:ext cx="5322720" cy="545953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698062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88F80-0CAC-7985-7EE3-305C698B9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1. </a:t>
            </a:r>
            <a:r>
              <a:rPr lang="de-DE" dirty="0" err="1"/>
              <a:t>Purificat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mEGFP</a:t>
            </a:r>
            <a:endParaRPr lang="de-DE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5D453EA-3B7E-0178-E075-A2D47D657976}"/>
              </a:ext>
            </a:extLst>
          </p:cNvPr>
          <p:cNvSpPr txBox="1"/>
          <p:nvPr/>
        </p:nvSpPr>
        <p:spPr>
          <a:xfrm>
            <a:off x="1033035" y="1481139"/>
            <a:ext cx="77285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S1. SDS-PAGE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IMAC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purificatio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mEGFP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CE000E2-CD3D-96CA-C704-3401878AAE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03681" y="1987002"/>
            <a:ext cx="4850119" cy="3816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13733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88F80-0CAC-7985-7EE3-305C698B9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2. </a:t>
            </a:r>
            <a:r>
              <a:rPr lang="de-DE" dirty="0" err="1"/>
              <a:t>mEGFP</a:t>
            </a:r>
            <a:r>
              <a:rPr lang="de-DE" dirty="0"/>
              <a:t> </a:t>
            </a:r>
            <a:r>
              <a:rPr lang="de-DE" dirty="0" err="1"/>
              <a:t>calibration</a:t>
            </a:r>
            <a:r>
              <a:rPr lang="de-DE" dirty="0"/>
              <a:t> </a:t>
            </a:r>
            <a:r>
              <a:rPr lang="de-DE" dirty="0" err="1"/>
              <a:t>using</a:t>
            </a:r>
            <a:r>
              <a:rPr lang="de-DE" dirty="0"/>
              <a:t> </a:t>
            </a:r>
            <a:r>
              <a:rPr lang="de-DE" dirty="0" err="1"/>
              <a:t>FPCountR</a:t>
            </a:r>
            <a:r>
              <a:rPr lang="de-DE" dirty="0"/>
              <a:t>*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5D453EA-3B7E-0178-E075-A2D47D657976}"/>
              </a:ext>
            </a:extLst>
          </p:cNvPr>
          <p:cNvSpPr txBox="1"/>
          <p:nvPr/>
        </p:nvSpPr>
        <p:spPr>
          <a:xfrm>
            <a:off x="838200" y="1811773"/>
            <a:ext cx="5481320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S2.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pectrum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raw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(220-1000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2-fold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dilu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erie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mEGFP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Desalti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Buffer (in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duplicat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Measurement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pectrum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LUOsta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Omega (BMG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Labtec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GmbH)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Processing and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lotti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lot_absorbance_spectrum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()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unk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in R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7B6984-0A4D-8B70-6776-68D763FA3703}"/>
              </a:ext>
            </a:extLst>
          </p:cNvPr>
          <p:cNvSpPr txBox="1"/>
          <p:nvPr/>
        </p:nvSpPr>
        <p:spPr>
          <a:xfrm>
            <a:off x="423434" y="6097696"/>
            <a:ext cx="6302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ibra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., Stan, G.-B., Absolute protein quantification using fluorescence measurements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PCountR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mun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22,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6600. doi:10.1038/s41467-022-34232-6</a:t>
            </a:r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6410DDF-4073-D151-2038-69B5627A0E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35057" y="1278985"/>
            <a:ext cx="5133509" cy="53647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23483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88F80-0CAC-7985-7EE3-305C698B9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2. </a:t>
            </a:r>
            <a:r>
              <a:rPr lang="de-DE" dirty="0" err="1"/>
              <a:t>mEGFP</a:t>
            </a:r>
            <a:r>
              <a:rPr lang="de-DE" dirty="0"/>
              <a:t> </a:t>
            </a:r>
            <a:r>
              <a:rPr lang="de-DE" dirty="0" err="1"/>
              <a:t>calibration</a:t>
            </a:r>
            <a:r>
              <a:rPr lang="de-DE" dirty="0"/>
              <a:t> </a:t>
            </a:r>
            <a:r>
              <a:rPr lang="de-DE" dirty="0" err="1"/>
              <a:t>using</a:t>
            </a:r>
            <a:r>
              <a:rPr lang="de-DE" dirty="0"/>
              <a:t> </a:t>
            </a:r>
            <a:r>
              <a:rPr lang="de-DE" dirty="0" err="1"/>
              <a:t>FPCountR</a:t>
            </a:r>
            <a:r>
              <a:rPr lang="de-DE" dirty="0"/>
              <a:t>*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5D453EA-3B7E-0178-E075-A2D47D657976}"/>
              </a:ext>
            </a:extLst>
          </p:cNvPr>
          <p:cNvSpPr txBox="1"/>
          <p:nvPr/>
        </p:nvSpPr>
        <p:spPr>
          <a:xfrm>
            <a:off x="838200" y="1811773"/>
            <a:ext cx="56134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S3.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pectrum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orrected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pathlength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b="1" i="1" dirty="0" err="1">
                <a:latin typeface="Arial" panose="020B0604020202020204" pitchFamily="34" charset="0"/>
                <a:cs typeface="Arial" panose="020B0604020202020204" pitchFamily="34" charset="0"/>
              </a:rPr>
              <a:t>pl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= 1 cm)</a:t>
            </a:r>
          </a:p>
          <a:p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athlengt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rrec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volum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v = 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200 µL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7B6984-0A4D-8B70-6776-68D763FA3703}"/>
              </a:ext>
            </a:extLst>
          </p:cNvPr>
          <p:cNvSpPr txBox="1"/>
          <p:nvPr/>
        </p:nvSpPr>
        <p:spPr>
          <a:xfrm>
            <a:off x="423434" y="6097696"/>
            <a:ext cx="6302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ibra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., Stan, G.-B., Absolute protein quantification using fluorescence measurements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PCountR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mun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22,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6600. doi:10.1038/s41467-022-34232-6</a:t>
            </a:r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0E862C7-9703-5CB5-9522-2EDB92D9C8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83680" y="1389596"/>
            <a:ext cx="5371709" cy="50485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82552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88F80-0CAC-7985-7EE3-305C698B9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2. </a:t>
            </a:r>
            <a:r>
              <a:rPr lang="de-DE" dirty="0" err="1"/>
              <a:t>mEGFP</a:t>
            </a:r>
            <a:r>
              <a:rPr lang="de-DE" dirty="0"/>
              <a:t> </a:t>
            </a:r>
            <a:r>
              <a:rPr lang="de-DE" dirty="0" err="1"/>
              <a:t>calibration</a:t>
            </a:r>
            <a:r>
              <a:rPr lang="de-DE" dirty="0"/>
              <a:t> </a:t>
            </a:r>
            <a:r>
              <a:rPr lang="de-DE" dirty="0" err="1"/>
              <a:t>using</a:t>
            </a:r>
            <a:r>
              <a:rPr lang="de-DE" dirty="0"/>
              <a:t> </a:t>
            </a:r>
            <a:r>
              <a:rPr lang="de-DE" dirty="0" err="1"/>
              <a:t>FPCountR</a:t>
            </a:r>
            <a:r>
              <a:rPr lang="de-DE" dirty="0"/>
              <a:t>*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5D453EA-3B7E-0178-E075-A2D47D657976}"/>
              </a:ext>
            </a:extLst>
          </p:cNvPr>
          <p:cNvSpPr txBox="1"/>
          <p:nvPr/>
        </p:nvSpPr>
        <p:spPr>
          <a:xfrm>
            <a:off x="838200" y="1811773"/>
            <a:ext cx="5613400" cy="14157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S4.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pectrum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orrected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athlengt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rrec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volum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v = 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200 µL)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ubstrac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buffe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(N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7B6984-0A4D-8B70-6776-68D763FA3703}"/>
              </a:ext>
            </a:extLst>
          </p:cNvPr>
          <p:cNvSpPr txBox="1"/>
          <p:nvPr/>
        </p:nvSpPr>
        <p:spPr>
          <a:xfrm>
            <a:off x="423434" y="6097696"/>
            <a:ext cx="6302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ibra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., Stan, G.-B., Absolute protein quantification using fluorescence measurements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PCountR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mun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22,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6600. doi:10.1038/s41467-022-34232-6</a:t>
            </a:r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2D89965A-5474-A320-C80D-85F4B151FD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44640" y="1245591"/>
            <a:ext cx="5205206" cy="49487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4292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88F80-0CAC-7985-7EE3-305C698B9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2. </a:t>
            </a:r>
            <a:r>
              <a:rPr lang="de-DE" dirty="0" err="1"/>
              <a:t>mEGFP</a:t>
            </a:r>
            <a:r>
              <a:rPr lang="de-DE" dirty="0"/>
              <a:t> </a:t>
            </a:r>
            <a:r>
              <a:rPr lang="de-DE" dirty="0" err="1"/>
              <a:t>calibration</a:t>
            </a:r>
            <a:r>
              <a:rPr lang="de-DE" dirty="0"/>
              <a:t> </a:t>
            </a:r>
            <a:r>
              <a:rPr lang="de-DE" dirty="0" err="1"/>
              <a:t>using</a:t>
            </a:r>
            <a:r>
              <a:rPr lang="de-DE" dirty="0"/>
              <a:t> </a:t>
            </a:r>
            <a:r>
              <a:rPr lang="de-DE" dirty="0" err="1"/>
              <a:t>FPCountR</a:t>
            </a:r>
            <a:r>
              <a:rPr lang="de-DE" dirty="0"/>
              <a:t>*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5D453EA-3B7E-0178-E075-A2D47D657976}"/>
              </a:ext>
            </a:extLst>
          </p:cNvPr>
          <p:cNvSpPr txBox="1"/>
          <p:nvPr/>
        </p:nvSpPr>
        <p:spPr>
          <a:xfrm>
            <a:off x="838200" y="1811773"/>
            <a:ext cx="561340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S5.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pectrum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orrected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athlengt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rrec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volum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600" i="1" dirty="0">
                <a:latin typeface="Arial" panose="020B0604020202020204" pitchFamily="34" charset="0"/>
                <a:cs typeface="Arial" panose="020B0604020202020204" pitchFamily="34" charset="0"/>
              </a:rPr>
              <a:t>v = 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200 µL)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ubstrac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buffe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(NA)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Here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represent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replicates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Unfortunately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haracteristic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maximum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eak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expect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at 488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nly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visible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dilu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1, 0.5 and 0.2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7B6984-0A4D-8B70-6776-68D763FA3703}"/>
              </a:ext>
            </a:extLst>
          </p:cNvPr>
          <p:cNvSpPr txBox="1"/>
          <p:nvPr/>
        </p:nvSpPr>
        <p:spPr>
          <a:xfrm>
            <a:off x="423434" y="6097696"/>
            <a:ext cx="6302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ibra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., Stan, G.-B., Absolute protein quantification using fluorescence measurements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PCountR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mun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22,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6600. doi:10.1038/s41467-022-34232-6</a:t>
            </a:r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1D8FE5C-A8A5-112B-2512-731109860F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84735" y="1303604"/>
            <a:ext cx="5428749" cy="4775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51235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88F80-0CAC-7985-7EE3-305C698B9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2. </a:t>
            </a:r>
            <a:r>
              <a:rPr lang="de-DE" dirty="0" err="1"/>
              <a:t>mEGFP</a:t>
            </a:r>
            <a:r>
              <a:rPr lang="de-DE" dirty="0"/>
              <a:t> </a:t>
            </a:r>
            <a:r>
              <a:rPr lang="de-DE" dirty="0" err="1"/>
              <a:t>calibration</a:t>
            </a:r>
            <a:r>
              <a:rPr lang="de-DE" dirty="0"/>
              <a:t> </a:t>
            </a:r>
            <a:r>
              <a:rPr lang="de-DE" dirty="0" err="1"/>
              <a:t>using</a:t>
            </a:r>
            <a:r>
              <a:rPr lang="de-DE" dirty="0"/>
              <a:t> </a:t>
            </a:r>
            <a:r>
              <a:rPr lang="de-DE" dirty="0" err="1"/>
              <a:t>FPCountR</a:t>
            </a:r>
            <a:r>
              <a:rPr lang="de-DE" dirty="0"/>
              <a:t>*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5D453EA-3B7E-0178-E075-A2D47D657976}"/>
              </a:ext>
            </a:extLst>
          </p:cNvPr>
          <p:cNvSpPr txBox="1"/>
          <p:nvPr/>
        </p:nvSpPr>
        <p:spPr>
          <a:xfrm>
            <a:off x="838200" y="1811773"/>
            <a:ext cx="561340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S6. Model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tting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normalizatio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pectrum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alculat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get_conc_Ecmax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()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redic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Fitting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Loes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Model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7B6984-0A4D-8B70-6776-68D763FA3703}"/>
              </a:ext>
            </a:extLst>
          </p:cNvPr>
          <p:cNvSpPr txBox="1"/>
          <p:nvPr/>
        </p:nvSpPr>
        <p:spPr>
          <a:xfrm>
            <a:off x="423434" y="6097696"/>
            <a:ext cx="6302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ibra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., Stan, G.-B., Absolute protein quantification using fluorescence measurements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PCountR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mun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22,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6600. doi:10.1038/s41467-022-34232-6</a:t>
            </a:r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07BAA05-4F38-E43F-4F94-9A442AF6E4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51600" y="1548789"/>
            <a:ext cx="5448615" cy="41577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77394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88F80-0CAC-7985-7EE3-305C698B9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2. </a:t>
            </a:r>
            <a:r>
              <a:rPr lang="de-DE" dirty="0" err="1"/>
              <a:t>mEGFP</a:t>
            </a:r>
            <a:r>
              <a:rPr lang="de-DE" dirty="0"/>
              <a:t> </a:t>
            </a:r>
            <a:r>
              <a:rPr lang="de-DE" dirty="0" err="1"/>
              <a:t>calibration</a:t>
            </a:r>
            <a:r>
              <a:rPr lang="de-DE" dirty="0"/>
              <a:t> </a:t>
            </a:r>
            <a:r>
              <a:rPr lang="de-DE" dirty="0" err="1"/>
              <a:t>using</a:t>
            </a:r>
            <a:r>
              <a:rPr lang="de-DE" dirty="0"/>
              <a:t> </a:t>
            </a:r>
            <a:r>
              <a:rPr lang="de-DE" dirty="0" err="1"/>
              <a:t>FPCountR</a:t>
            </a:r>
            <a:r>
              <a:rPr lang="de-DE" dirty="0"/>
              <a:t>*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5D453EA-3B7E-0178-E075-A2D47D657976}"/>
              </a:ext>
            </a:extLst>
          </p:cNvPr>
          <p:cNvSpPr txBox="1"/>
          <p:nvPr/>
        </p:nvSpPr>
        <p:spPr>
          <a:xfrm>
            <a:off x="838200" y="1811773"/>
            <a:ext cx="5613400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S7. Model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tting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normalizatio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pectrum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alculat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get_conc_ECmax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()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redic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Fitting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Loes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Model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Normaliza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catte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Properties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mEGFP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accordi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pbase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Linear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model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itt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rrec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metho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dilu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redict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7B6984-0A4D-8B70-6776-68D763FA3703}"/>
              </a:ext>
            </a:extLst>
          </p:cNvPr>
          <p:cNvSpPr txBox="1"/>
          <p:nvPr/>
        </p:nvSpPr>
        <p:spPr>
          <a:xfrm>
            <a:off x="423434" y="6097696"/>
            <a:ext cx="6302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ibra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., Stan, G.-B., Absolute protein quantification using fluorescence measurements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PCountR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mun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22,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6600. doi:10.1038/s41467-022-34232-6</a:t>
            </a:r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dirty="0"/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55E4D5B4-AF33-FA69-8EDF-3A599FFB59E1}"/>
              </a:ext>
            </a:extLst>
          </p:cNvPr>
          <p:cNvGraphicFramePr>
            <a:graphicFrameLocks noGrp="1"/>
          </p:cNvGraphicFramePr>
          <p:nvPr/>
        </p:nvGraphicFramePr>
        <p:xfrm>
          <a:off x="1136201" y="4124474"/>
          <a:ext cx="5237480" cy="640080"/>
        </p:xfrm>
        <a:graphic>
          <a:graphicData uri="http://schemas.openxmlformats.org/drawingml/2006/table">
            <a:tbl>
              <a:tblPr firstRow="1" firstCol="1" bandRow="1"/>
              <a:tblGrid>
                <a:gridCol w="1073862">
                  <a:extLst>
                    <a:ext uri="{9D8B030D-6E8A-4147-A177-3AD203B41FA5}">
                      <a16:colId xmlns:a16="http://schemas.microsoft.com/office/drawing/2014/main" val="2459102798"/>
                    </a:ext>
                  </a:extLst>
                </a:gridCol>
                <a:gridCol w="1288085">
                  <a:extLst>
                    <a:ext uri="{9D8B030D-6E8A-4147-A177-3AD203B41FA5}">
                      <a16:colId xmlns:a16="http://schemas.microsoft.com/office/drawing/2014/main" val="3933291008"/>
                    </a:ext>
                  </a:extLst>
                </a:gridCol>
                <a:gridCol w="1503681">
                  <a:extLst>
                    <a:ext uri="{9D8B030D-6E8A-4147-A177-3AD203B41FA5}">
                      <a16:colId xmlns:a16="http://schemas.microsoft.com/office/drawing/2014/main" val="2986457315"/>
                    </a:ext>
                  </a:extLst>
                </a:gridCol>
                <a:gridCol w="1371852">
                  <a:extLst>
                    <a:ext uri="{9D8B030D-6E8A-4147-A177-3AD203B41FA5}">
                      <a16:colId xmlns:a16="http://schemas.microsoft.com/office/drawing/2014/main" val="64032612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spcBef>
                          <a:spcPts val="480"/>
                        </a:spcBef>
                        <a:spcAft>
                          <a:spcPts val="48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citation max. </a:t>
                      </a: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λ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480"/>
                        </a:spcBef>
                        <a:spcAft>
                          <a:spcPts val="48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mission max. </a:t>
                      </a: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λ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480"/>
                        </a:spcBef>
                        <a:spcAft>
                          <a:spcPts val="48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tinction coefficient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480"/>
                        </a:spcBef>
                        <a:spcAft>
                          <a:spcPts val="480"/>
                        </a:spcAft>
                      </a:pPr>
                      <a:r>
                        <a:rPr lang="en-GB" sz="12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lecular weight</a:t>
                      </a:r>
                      <a:endParaRPr lang="de-DE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60001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200"/>
                        </a:spcBef>
                        <a:spcAft>
                          <a:spcPts val="600"/>
                        </a:spcAft>
                      </a:pP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88 nm</a:t>
                      </a:r>
                      <a:endParaRPr lang="de-DE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200"/>
                        </a:spcBef>
                        <a:spcAft>
                          <a:spcPts val="600"/>
                        </a:spcAft>
                      </a:pP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7 nm</a:t>
                      </a:r>
                      <a:endParaRPr lang="de-DE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200"/>
                        </a:spcBef>
                        <a:spcAft>
                          <a:spcPts val="600"/>
                        </a:spcAft>
                      </a:pP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6000 M</a:t>
                      </a:r>
                      <a:r>
                        <a:rPr lang="en-GB" sz="12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GB" sz="12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cm</a:t>
                      </a:r>
                      <a:r>
                        <a:rPr lang="en-GB" sz="1200" baseline="30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de-DE" sz="12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200"/>
                        </a:spcBef>
                        <a:spcAft>
                          <a:spcPts val="600"/>
                        </a:spcAft>
                      </a:pPr>
                      <a:r>
                        <a:rPr lang="en-GB" sz="12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7 </a:t>
                      </a:r>
                      <a:r>
                        <a:rPr lang="en-GB" sz="12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DA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0597864"/>
                  </a:ext>
                </a:extLst>
              </a:tr>
            </a:tbl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ECAB687E-EAF8-A466-2861-F8130EAA30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71682" y="3945333"/>
            <a:ext cx="5173853" cy="269843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16466AF-36AD-38E8-36A6-2C554760F0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59242" y="1645025"/>
            <a:ext cx="1954158" cy="198262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2935689-E4ED-9E3D-FAEB-9476C095D4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13400" y="1618854"/>
            <a:ext cx="1964605" cy="198262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59F18A4-9DF0-F158-4DBE-FBD6630A7EAB}"/>
              </a:ext>
            </a:extLst>
          </p:cNvPr>
          <p:cNvSpPr txBox="1"/>
          <p:nvPr/>
        </p:nvSpPr>
        <p:spPr>
          <a:xfrm>
            <a:off x="6391294" y="1408017"/>
            <a:ext cx="47867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Correction</a:t>
            </a:r>
            <a:r>
              <a:rPr lang="de-DE" sz="1600" dirty="0"/>
              <a:t>:             </a:t>
            </a:r>
            <a:r>
              <a:rPr lang="de-DE" sz="1600" dirty="0" err="1"/>
              <a:t>baseline</a:t>
            </a:r>
            <a:r>
              <a:rPr lang="de-DE" sz="1600" dirty="0"/>
              <a:t>                                </a:t>
            </a:r>
            <a:r>
              <a:rPr lang="de-DE" sz="1600" dirty="0" err="1"/>
              <a:t>scatter</a:t>
            </a:r>
            <a:r>
              <a:rPr lang="de-DE" sz="1600" dirty="0"/>
              <a:t> 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67B433E-2198-AC38-0818-59B646127256}"/>
              </a:ext>
            </a:extLst>
          </p:cNvPr>
          <p:cNvSpPr txBox="1"/>
          <p:nvPr/>
        </p:nvSpPr>
        <p:spPr>
          <a:xfrm>
            <a:off x="6533534" y="3955197"/>
            <a:ext cx="58567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err="1"/>
              <a:t>Predicted</a:t>
            </a:r>
            <a:r>
              <a:rPr lang="de-DE" sz="1600" dirty="0"/>
              <a:t> </a:t>
            </a:r>
            <a:r>
              <a:rPr lang="de-DE" sz="1600" dirty="0" err="1"/>
              <a:t>concentration</a:t>
            </a:r>
            <a:r>
              <a:rPr lang="de-DE" sz="1600" dirty="0"/>
              <a:t> (</a:t>
            </a:r>
            <a:r>
              <a:rPr lang="de-DE" sz="1600" dirty="0" err="1"/>
              <a:t>for</a:t>
            </a:r>
            <a:r>
              <a:rPr lang="de-DE" sz="1600" dirty="0"/>
              <a:t> </a:t>
            </a:r>
            <a:r>
              <a:rPr lang="de-DE" sz="1600" dirty="0" err="1"/>
              <a:t>the</a:t>
            </a:r>
            <a:r>
              <a:rPr lang="de-DE" sz="1600" dirty="0"/>
              <a:t> different </a:t>
            </a:r>
            <a:r>
              <a:rPr lang="de-DE" sz="1600" dirty="0" err="1"/>
              <a:t>correction</a:t>
            </a:r>
            <a:r>
              <a:rPr lang="de-DE" sz="1600" dirty="0"/>
              <a:t> </a:t>
            </a:r>
            <a:r>
              <a:rPr lang="de-DE" sz="1600" dirty="0" err="1"/>
              <a:t>method</a:t>
            </a:r>
            <a:r>
              <a:rPr lang="de-DE" sz="16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216823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88F80-0CAC-7985-7EE3-305C698B9B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2. </a:t>
            </a:r>
            <a:r>
              <a:rPr lang="de-DE" dirty="0" err="1"/>
              <a:t>mEGFP</a:t>
            </a:r>
            <a:r>
              <a:rPr lang="de-DE" dirty="0"/>
              <a:t> </a:t>
            </a:r>
            <a:r>
              <a:rPr lang="de-DE" dirty="0" err="1"/>
              <a:t>calibration</a:t>
            </a:r>
            <a:r>
              <a:rPr lang="de-DE" dirty="0"/>
              <a:t> </a:t>
            </a:r>
            <a:r>
              <a:rPr lang="de-DE" dirty="0" err="1"/>
              <a:t>using</a:t>
            </a:r>
            <a:r>
              <a:rPr lang="de-DE" dirty="0"/>
              <a:t> </a:t>
            </a:r>
            <a:r>
              <a:rPr lang="de-DE" dirty="0" err="1"/>
              <a:t>FPCountR</a:t>
            </a:r>
            <a:r>
              <a:rPr lang="de-DE" dirty="0"/>
              <a:t>*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5D453EA-3B7E-0178-E075-A2D47D657976}"/>
              </a:ext>
            </a:extLst>
          </p:cNvPr>
          <p:cNvSpPr txBox="1"/>
          <p:nvPr/>
        </p:nvSpPr>
        <p:spPr>
          <a:xfrm>
            <a:off x="838200" y="1811773"/>
            <a:ext cx="5613400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S8. Model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tting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normalizatio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absorbanc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pectrum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alculat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get_conc_Ecmax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()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redic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ncentra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I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hosed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catte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normalization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furthe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catter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tween A</a:t>
            </a:r>
            <a:r>
              <a:rPr lang="en-GB" sz="16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390nm</a:t>
            </a:r>
            <a:r>
              <a:rPr lang="en-GB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the </a:t>
            </a:r>
            <a:r>
              <a:rPr lang="en-GB" sz="16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C</a:t>
            </a:r>
            <a:r>
              <a:rPr lang="en-GB" sz="1600" baseline="-25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x</a:t>
            </a:r>
            <a:r>
              <a:rPr lang="en-GB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velength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sz="1600" dirty="0">
                <a:latin typeface="Arial" panose="020B0604020202020204" pitchFamily="34" charset="0"/>
                <a:cs typeface="Times New Roman" panose="02020603050405020304" pitchFamily="18" charset="0"/>
              </a:rPr>
              <a:t>Unfortunately, higher concentration matched the linear model better than the dilution containing lower protein concentration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42950" lvl="1" indent="-285750">
              <a:buFont typeface="Arial" panose="020B0604020202020204" pitchFamily="34" charset="0"/>
              <a:buChar char="•"/>
            </a:pP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7B6984-0A4D-8B70-6776-68D763FA3703}"/>
              </a:ext>
            </a:extLst>
          </p:cNvPr>
          <p:cNvSpPr txBox="1"/>
          <p:nvPr/>
        </p:nvSpPr>
        <p:spPr>
          <a:xfrm>
            <a:off x="423434" y="6097696"/>
            <a:ext cx="63024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ibra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., Stan, G.-B., Absolute protein quantification using fluorescence measurements with </a:t>
            </a:r>
            <a:r>
              <a:rPr lang="en-GB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PCountR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 </a:t>
            </a:r>
            <a:r>
              <a:rPr lang="en-GB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mun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022, </a:t>
            </a:r>
            <a:r>
              <a:rPr lang="en-GB" sz="12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6600. doi:10.1038/s41467-022-34232-6</a:t>
            </a:r>
            <a:r>
              <a:rPr lang="en-GB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dirty="0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BA468C36-78BC-3139-4D5A-CC6895B674D1}"/>
              </a:ext>
            </a:extLst>
          </p:cNvPr>
          <p:cNvGrpSpPr/>
          <p:nvPr/>
        </p:nvGrpSpPr>
        <p:grpSpPr>
          <a:xfrm>
            <a:off x="6522720" y="1676432"/>
            <a:ext cx="5349165" cy="2827265"/>
            <a:chOff x="-19685" y="3474752"/>
            <a:chExt cx="5349165" cy="2827265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DD4B36A2-51A3-A3B6-143F-7A22AAFF68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19685" y="3474752"/>
              <a:ext cx="2796782" cy="2827265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C2CA3DFE-CF5B-A5F5-7116-EA84F557BE3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77539" y="3522483"/>
              <a:ext cx="2651941" cy="263020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066331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4</Words>
  <Application>Microsoft Office PowerPoint</Application>
  <PresentationFormat>Breitbild</PresentationFormat>
  <Paragraphs>112</Paragraphs>
  <Slides>1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</vt:lpstr>
      <vt:lpstr>PowerPoint-Präsentation</vt:lpstr>
      <vt:lpstr>1. Purification of mEGFP</vt:lpstr>
      <vt:lpstr>2. mEGFP calibration using FPCountR*</vt:lpstr>
      <vt:lpstr>2. mEGFP calibration using FPCountR*</vt:lpstr>
      <vt:lpstr>2. mEGFP calibration using FPCountR*</vt:lpstr>
      <vt:lpstr>2. mEGFP calibration using FPCountR*</vt:lpstr>
      <vt:lpstr>2. mEGFP calibration using FPCountR*</vt:lpstr>
      <vt:lpstr>2. mEGFP calibration using FPCountR*</vt:lpstr>
      <vt:lpstr>2. mEGFP calibration using FPCountR*</vt:lpstr>
      <vt:lpstr>2. mEGFP calibration using FPCountR*</vt:lpstr>
      <vt:lpstr>2. mEGFP calibration using FPCountR*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ults Masterthesis</dc:title>
  <dc:creator>Maliheh</dc:creator>
  <cp:lastModifiedBy>Maliheh Vahidinasab</cp:lastModifiedBy>
  <cp:revision>13</cp:revision>
  <dcterms:created xsi:type="dcterms:W3CDTF">2024-07-23T12:19:44Z</dcterms:created>
  <dcterms:modified xsi:type="dcterms:W3CDTF">2024-11-19T21:24:20Z</dcterms:modified>
</cp:coreProperties>
</file>